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841CECD-6CA5-495F-A987-1C66A6FE0162}" v="7" dt="2025-12-21T19:46:53.3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36" autoAdjust="0"/>
    <p:restoredTop sz="94660"/>
  </p:normalViewPr>
  <p:slideViewPr>
    <p:cSldViewPr snapToGrid="0">
      <p:cViewPr varScale="1">
        <p:scale>
          <a:sx n="150" d="100"/>
          <a:sy n="150" d="100"/>
        </p:scale>
        <p:origin x="294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lene Ganslmeier" userId="45c49ef3-bcd5-408a-93eb-0ba43e091784" providerId="ADAL" clId="{4CFBB918-5BDE-40A6-A2B3-78B74F2ECAAA}"/>
    <pc:docChg chg="undo custSel modSld">
      <pc:chgData name="Marlene Ganslmeier" userId="45c49ef3-bcd5-408a-93eb-0ba43e091784" providerId="ADAL" clId="{4CFBB918-5BDE-40A6-A2B3-78B74F2ECAAA}" dt="2025-12-21T19:47:35.049" v="252" actId="1076"/>
      <pc:docMkLst>
        <pc:docMk/>
      </pc:docMkLst>
      <pc:sldChg chg="addSp delSp modSp mod">
        <pc:chgData name="Marlene Ganslmeier" userId="45c49ef3-bcd5-408a-93eb-0ba43e091784" providerId="ADAL" clId="{4CFBB918-5BDE-40A6-A2B3-78B74F2ECAAA}" dt="2025-12-21T19:47:35.049" v="252" actId="1076"/>
        <pc:sldMkLst>
          <pc:docMk/>
          <pc:sldMk cId="190867312" sldId="256"/>
        </pc:sldMkLst>
        <pc:spChg chg="mod">
          <ac:chgData name="Marlene Ganslmeier" userId="45c49ef3-bcd5-408a-93eb-0ba43e091784" providerId="ADAL" clId="{4CFBB918-5BDE-40A6-A2B3-78B74F2ECAAA}" dt="2025-12-21T19:47:35.049" v="252" actId="1076"/>
          <ac:spMkLst>
            <pc:docMk/>
            <pc:sldMk cId="190867312" sldId="256"/>
            <ac:spMk id="4" creationId="{B4A7D2A8-F1EA-0C2D-65E1-F44665873BA0}"/>
          </ac:spMkLst>
        </pc:spChg>
        <pc:spChg chg="mod">
          <ac:chgData name="Marlene Ganslmeier" userId="45c49ef3-bcd5-408a-93eb-0ba43e091784" providerId="ADAL" clId="{4CFBB918-5BDE-40A6-A2B3-78B74F2ECAAA}" dt="2025-12-21T19:47:35.049" v="252" actId="1076"/>
          <ac:spMkLst>
            <pc:docMk/>
            <pc:sldMk cId="190867312" sldId="256"/>
            <ac:spMk id="5" creationId="{D3DE2DA3-5DE6-7FD3-FF91-6F2749F166E7}"/>
          </ac:spMkLst>
        </pc:spChg>
        <pc:spChg chg="mod">
          <ac:chgData name="Marlene Ganslmeier" userId="45c49ef3-bcd5-408a-93eb-0ba43e091784" providerId="ADAL" clId="{4CFBB918-5BDE-40A6-A2B3-78B74F2ECAAA}" dt="2025-12-21T19:47:35.049" v="252" actId="1076"/>
          <ac:spMkLst>
            <pc:docMk/>
            <pc:sldMk cId="190867312" sldId="256"/>
            <ac:spMk id="7" creationId="{50C251C0-E018-AB9D-F86F-7707C260ACFE}"/>
          </ac:spMkLst>
        </pc:spChg>
        <pc:spChg chg="mod">
          <ac:chgData name="Marlene Ganslmeier" userId="45c49ef3-bcd5-408a-93eb-0ba43e091784" providerId="ADAL" clId="{4CFBB918-5BDE-40A6-A2B3-78B74F2ECAAA}" dt="2025-12-21T19:47:35.049" v="252" actId="1076"/>
          <ac:spMkLst>
            <pc:docMk/>
            <pc:sldMk cId="190867312" sldId="256"/>
            <ac:spMk id="8" creationId="{2AD4E727-6AC9-D3F5-E078-B4FCE8F3A531}"/>
          </ac:spMkLst>
        </pc:spChg>
        <pc:spChg chg="mod">
          <ac:chgData name="Marlene Ganslmeier" userId="45c49ef3-bcd5-408a-93eb-0ba43e091784" providerId="ADAL" clId="{4CFBB918-5BDE-40A6-A2B3-78B74F2ECAAA}" dt="2025-12-21T19:47:35.049" v="252" actId="1076"/>
          <ac:spMkLst>
            <pc:docMk/>
            <pc:sldMk cId="190867312" sldId="256"/>
            <ac:spMk id="9" creationId="{E7957DA7-0A60-2CED-B8DE-B6EB84BB819E}"/>
          </ac:spMkLst>
        </pc:spChg>
        <pc:spChg chg="mod">
          <ac:chgData name="Marlene Ganslmeier" userId="45c49ef3-bcd5-408a-93eb-0ba43e091784" providerId="ADAL" clId="{4CFBB918-5BDE-40A6-A2B3-78B74F2ECAAA}" dt="2025-12-21T19:47:35.049" v="252" actId="1076"/>
          <ac:spMkLst>
            <pc:docMk/>
            <pc:sldMk cId="190867312" sldId="256"/>
            <ac:spMk id="10" creationId="{CCB6C968-94D5-93AD-F026-67B87E8018A5}"/>
          </ac:spMkLst>
        </pc:spChg>
        <pc:spChg chg="mod">
          <ac:chgData name="Marlene Ganslmeier" userId="45c49ef3-bcd5-408a-93eb-0ba43e091784" providerId="ADAL" clId="{4CFBB918-5BDE-40A6-A2B3-78B74F2ECAAA}" dt="2025-12-21T19:46:14.721" v="210" actId="20577"/>
          <ac:spMkLst>
            <pc:docMk/>
            <pc:sldMk cId="190867312" sldId="256"/>
            <ac:spMk id="17" creationId="{4755DF2B-849E-FAAF-56B4-C866CF68EFBF}"/>
          </ac:spMkLst>
        </pc:spChg>
        <pc:spChg chg="mod">
          <ac:chgData name="Marlene Ganslmeier" userId="45c49ef3-bcd5-408a-93eb-0ba43e091784" providerId="ADAL" clId="{4CFBB918-5BDE-40A6-A2B3-78B74F2ECAAA}" dt="2025-12-21T19:47:35.049" v="252" actId="1076"/>
          <ac:spMkLst>
            <pc:docMk/>
            <pc:sldMk cId="190867312" sldId="256"/>
            <ac:spMk id="19" creationId="{B61BA512-D8ED-96EF-1106-9A4E55C67130}"/>
          </ac:spMkLst>
        </pc:spChg>
        <pc:spChg chg="del mod">
          <ac:chgData name="Marlene Ganslmeier" userId="45c49ef3-bcd5-408a-93eb-0ba43e091784" providerId="ADAL" clId="{4CFBB918-5BDE-40A6-A2B3-78B74F2ECAAA}" dt="2025-12-21T19:45:50.207" v="190" actId="478"/>
          <ac:spMkLst>
            <pc:docMk/>
            <pc:sldMk cId="190867312" sldId="256"/>
            <ac:spMk id="25" creationId="{CE43E1FB-5F5C-4878-F46C-840CBC496036}"/>
          </ac:spMkLst>
        </pc:spChg>
        <pc:spChg chg="del mod">
          <ac:chgData name="Marlene Ganslmeier" userId="45c49ef3-bcd5-408a-93eb-0ba43e091784" providerId="ADAL" clId="{4CFBB918-5BDE-40A6-A2B3-78B74F2ECAAA}" dt="2025-12-21T19:45:50.207" v="190" actId="478"/>
          <ac:spMkLst>
            <pc:docMk/>
            <pc:sldMk cId="190867312" sldId="256"/>
            <ac:spMk id="27" creationId="{DA53A462-9712-C1D2-F08A-210F20072D01}"/>
          </ac:spMkLst>
        </pc:spChg>
        <pc:spChg chg="mod">
          <ac:chgData name="Marlene Ganslmeier" userId="45c49ef3-bcd5-408a-93eb-0ba43e091784" providerId="ADAL" clId="{4CFBB918-5BDE-40A6-A2B3-78B74F2ECAAA}" dt="2025-12-21T19:45:58.441" v="191" actId="164"/>
          <ac:spMkLst>
            <pc:docMk/>
            <pc:sldMk cId="190867312" sldId="256"/>
            <ac:spMk id="29" creationId="{99C1DEFB-B014-8205-7B12-F562F7C9C8F0}"/>
          </ac:spMkLst>
        </pc:spChg>
        <pc:spChg chg="mod">
          <ac:chgData name="Marlene Ganslmeier" userId="45c49ef3-bcd5-408a-93eb-0ba43e091784" providerId="ADAL" clId="{4CFBB918-5BDE-40A6-A2B3-78B74F2ECAAA}" dt="2025-12-21T19:47:07.344" v="247" actId="20577"/>
          <ac:spMkLst>
            <pc:docMk/>
            <pc:sldMk cId="190867312" sldId="256"/>
            <ac:spMk id="34" creationId="{0733E6EC-4F4F-A7D7-B8A7-B139641520B9}"/>
          </ac:spMkLst>
        </pc:spChg>
        <pc:grpChg chg="add mod">
          <ac:chgData name="Marlene Ganslmeier" userId="45c49ef3-bcd5-408a-93eb-0ba43e091784" providerId="ADAL" clId="{4CFBB918-5BDE-40A6-A2B3-78B74F2ECAAA}" dt="2025-12-21T19:47:35.049" v="252" actId="1076"/>
          <ac:grpSpMkLst>
            <pc:docMk/>
            <pc:sldMk cId="190867312" sldId="256"/>
            <ac:grpSpMk id="14" creationId="{81FE4473-55E4-FF89-B36E-49F07844EE3C}"/>
          </ac:grpSpMkLst>
        </pc:grpChg>
        <pc:grpChg chg="add mod">
          <ac:chgData name="Marlene Ganslmeier" userId="45c49ef3-bcd5-408a-93eb-0ba43e091784" providerId="ADAL" clId="{4CFBB918-5BDE-40A6-A2B3-78B74F2ECAAA}" dt="2025-12-21T19:47:35.049" v="252" actId="1076"/>
          <ac:grpSpMkLst>
            <pc:docMk/>
            <pc:sldMk cId="190867312" sldId="256"/>
            <ac:grpSpMk id="15" creationId="{B1B9C47C-9D57-E486-959A-6670FBCF3EAF}"/>
          </ac:grpSpMkLst>
        </pc:grpChg>
        <pc:grpChg chg="add mod">
          <ac:chgData name="Marlene Ganslmeier" userId="45c49ef3-bcd5-408a-93eb-0ba43e091784" providerId="ADAL" clId="{4CFBB918-5BDE-40A6-A2B3-78B74F2ECAAA}" dt="2025-12-21T19:47:35.049" v="252" actId="1076"/>
          <ac:grpSpMkLst>
            <pc:docMk/>
            <pc:sldMk cId="190867312" sldId="256"/>
            <ac:grpSpMk id="22" creationId="{2CC8B946-F682-980F-778B-09DE6D2140CB}"/>
          </ac:grpSpMkLst>
        </pc:grpChg>
        <pc:cxnChg chg="add del mod">
          <ac:chgData name="Marlene Ganslmeier" userId="45c49ef3-bcd5-408a-93eb-0ba43e091784" providerId="ADAL" clId="{4CFBB918-5BDE-40A6-A2B3-78B74F2ECAAA}" dt="2025-12-21T19:45:50.207" v="190" actId="478"/>
          <ac:cxnSpMkLst>
            <pc:docMk/>
            <pc:sldMk cId="190867312" sldId="256"/>
            <ac:cxnSpMk id="3" creationId="{7DEF5993-977B-2E8C-C49B-F7144A92D85A}"/>
          </ac:cxnSpMkLst>
        </pc:cxnChg>
        <pc:cxnChg chg="add del mod">
          <ac:chgData name="Marlene Ganslmeier" userId="45c49ef3-bcd5-408a-93eb-0ba43e091784" providerId="ADAL" clId="{4CFBB918-5BDE-40A6-A2B3-78B74F2ECAAA}" dt="2025-12-21T19:45:50.207" v="190" actId="478"/>
          <ac:cxnSpMkLst>
            <pc:docMk/>
            <pc:sldMk cId="190867312" sldId="256"/>
            <ac:cxnSpMk id="6" creationId="{CB9B0A92-B743-1BD7-FAAF-927189EB1746}"/>
          </ac:cxnSpMkLst>
        </pc:cxnChg>
        <pc:cxnChg chg="add mod">
          <ac:chgData name="Marlene Ganslmeier" userId="45c49ef3-bcd5-408a-93eb-0ba43e091784" providerId="ADAL" clId="{4CFBB918-5BDE-40A6-A2B3-78B74F2ECAAA}" dt="2025-12-21T19:47:12.332" v="248" actId="1076"/>
          <ac:cxnSpMkLst>
            <pc:docMk/>
            <pc:sldMk cId="190867312" sldId="256"/>
            <ac:cxnSpMk id="11" creationId="{3BB29444-EB96-83D1-58B9-7909DC140778}"/>
          </ac:cxnSpMkLst>
        </pc:cxnChg>
        <pc:cxnChg chg="mod">
          <ac:chgData name="Marlene Ganslmeier" userId="45c49ef3-bcd5-408a-93eb-0ba43e091784" providerId="ADAL" clId="{4CFBB918-5BDE-40A6-A2B3-78B74F2ECAAA}" dt="2025-12-21T19:44:53.879" v="181" actId="12788"/>
          <ac:cxnSpMkLst>
            <pc:docMk/>
            <pc:sldMk cId="190867312" sldId="256"/>
            <ac:cxnSpMk id="12" creationId="{AE12058C-582F-AAF4-6AA3-FF7E367CA28B}"/>
          </ac:cxnSpMkLst>
        </pc:cxnChg>
        <pc:cxnChg chg="mod">
          <ac:chgData name="Marlene Ganslmeier" userId="45c49ef3-bcd5-408a-93eb-0ba43e091784" providerId="ADAL" clId="{4CFBB918-5BDE-40A6-A2B3-78B74F2ECAAA}" dt="2025-12-21T19:43:47.848" v="165" actId="1076"/>
          <ac:cxnSpMkLst>
            <pc:docMk/>
            <pc:sldMk cId="190867312" sldId="256"/>
            <ac:cxnSpMk id="13" creationId="{788454D9-27DA-5566-773D-CF2ECCD9B714}"/>
          </ac:cxnSpMkLst>
        </pc:cxnChg>
        <pc:cxnChg chg="mod">
          <ac:chgData name="Marlene Ganslmeier" userId="45c49ef3-bcd5-408a-93eb-0ba43e091784" providerId="ADAL" clId="{4CFBB918-5BDE-40A6-A2B3-78B74F2ECAAA}" dt="2025-12-21T19:45:59.103" v="192"/>
          <ac:cxnSpMkLst>
            <pc:docMk/>
            <pc:sldMk cId="190867312" sldId="256"/>
            <ac:cxnSpMk id="16" creationId="{58DA4F21-F38A-9FDA-5D7C-DDE74124E68B}"/>
          </ac:cxnSpMkLst>
        </pc:cxnChg>
        <pc:cxnChg chg="del">
          <ac:chgData name="Marlene Ganslmeier" userId="45c49ef3-bcd5-408a-93eb-0ba43e091784" providerId="ADAL" clId="{4CFBB918-5BDE-40A6-A2B3-78B74F2ECAAA}" dt="2025-12-21T19:44:06.042" v="169" actId="478"/>
          <ac:cxnSpMkLst>
            <pc:docMk/>
            <pc:sldMk cId="190867312" sldId="256"/>
            <ac:cxnSpMk id="18" creationId="{BC24B356-003A-DAA6-2D20-D45B6E497F2A}"/>
          </ac:cxnSpMkLst>
        </pc:cxnChg>
        <pc:cxnChg chg="mod">
          <ac:chgData name="Marlene Ganslmeier" userId="45c49ef3-bcd5-408a-93eb-0ba43e091784" providerId="ADAL" clId="{4CFBB918-5BDE-40A6-A2B3-78B74F2ECAAA}" dt="2025-12-21T19:43:45.105" v="164" actId="1076"/>
          <ac:cxnSpMkLst>
            <pc:docMk/>
            <pc:sldMk cId="190867312" sldId="256"/>
            <ac:cxnSpMk id="20" creationId="{46B22CD7-0DBF-F734-AB9C-EF5FAF751D5C}"/>
          </ac:cxnSpMkLst>
        </pc:cxnChg>
        <pc:cxnChg chg="mod">
          <ac:chgData name="Marlene Ganslmeier" userId="45c49ef3-bcd5-408a-93eb-0ba43e091784" providerId="ADAL" clId="{4CFBB918-5BDE-40A6-A2B3-78B74F2ECAAA}" dt="2025-12-21T19:45:59.103" v="192"/>
          <ac:cxnSpMkLst>
            <pc:docMk/>
            <pc:sldMk cId="190867312" sldId="256"/>
            <ac:cxnSpMk id="21" creationId="{D2348165-36E0-C5C2-B564-9D57DD6A2D4D}"/>
          </ac:cxnSpMkLst>
        </pc:cxnChg>
        <pc:cxnChg chg="mod">
          <ac:chgData name="Marlene Ganslmeier" userId="45c49ef3-bcd5-408a-93eb-0ba43e091784" providerId="ADAL" clId="{4CFBB918-5BDE-40A6-A2B3-78B74F2ECAAA}" dt="2025-12-21T19:43:45.105" v="164" actId="1076"/>
          <ac:cxnSpMkLst>
            <pc:docMk/>
            <pc:sldMk cId="190867312" sldId="256"/>
            <ac:cxnSpMk id="23" creationId="{D767F37E-384F-5B10-65CD-53C1A8C97653}"/>
          </ac:cxnSpMkLst>
        </pc:cxnChg>
        <pc:cxnChg chg="del">
          <ac:chgData name="Marlene Ganslmeier" userId="45c49ef3-bcd5-408a-93eb-0ba43e091784" providerId="ADAL" clId="{4CFBB918-5BDE-40A6-A2B3-78B74F2ECAAA}" dt="2025-12-21T19:44:07.305" v="170" actId="478"/>
          <ac:cxnSpMkLst>
            <pc:docMk/>
            <pc:sldMk cId="190867312" sldId="256"/>
            <ac:cxnSpMk id="24" creationId="{B9122EE4-ED5D-FB2D-ED4D-2DE6D0A38182}"/>
          </ac:cxnSpMkLst>
        </pc:cxnChg>
        <pc:cxnChg chg="del">
          <ac:chgData name="Marlene Ganslmeier" userId="45c49ef3-bcd5-408a-93eb-0ba43e091784" providerId="ADAL" clId="{4CFBB918-5BDE-40A6-A2B3-78B74F2ECAAA}" dt="2025-12-21T19:44:04.853" v="168" actId="478"/>
          <ac:cxnSpMkLst>
            <pc:docMk/>
            <pc:sldMk cId="190867312" sldId="256"/>
            <ac:cxnSpMk id="26" creationId="{9E4332A1-FCC7-E0A7-3C1D-E7EA8C84ED45}"/>
          </ac:cxnSpMkLst>
        </pc:cxnChg>
        <pc:cxnChg chg="mod">
          <ac:chgData name="Marlene Ganslmeier" userId="45c49ef3-bcd5-408a-93eb-0ba43e091784" providerId="ADAL" clId="{4CFBB918-5BDE-40A6-A2B3-78B74F2ECAAA}" dt="2025-12-21T19:45:58.441" v="191" actId="164"/>
          <ac:cxnSpMkLst>
            <pc:docMk/>
            <pc:sldMk cId="190867312" sldId="256"/>
            <ac:cxnSpMk id="28" creationId="{6978076B-BC2E-7A5C-BC63-2E81DD5D51FA}"/>
          </ac:cxnSpMkLst>
        </pc:cxnChg>
        <pc:cxnChg chg="mod">
          <ac:chgData name="Marlene Ganslmeier" userId="45c49ef3-bcd5-408a-93eb-0ba43e091784" providerId="ADAL" clId="{4CFBB918-5BDE-40A6-A2B3-78B74F2ECAAA}" dt="2025-12-21T19:45:58.441" v="191" actId="164"/>
          <ac:cxnSpMkLst>
            <pc:docMk/>
            <pc:sldMk cId="190867312" sldId="256"/>
            <ac:cxnSpMk id="30" creationId="{DA629F87-20BD-60FD-34D0-579AC8A3ED64}"/>
          </ac:cxnSpMkLst>
        </pc:cxnChg>
        <pc:cxnChg chg="mod">
          <ac:chgData name="Marlene Ganslmeier" userId="45c49ef3-bcd5-408a-93eb-0ba43e091784" providerId="ADAL" clId="{4CFBB918-5BDE-40A6-A2B3-78B74F2ECAAA}" dt="2025-12-21T19:46:53.386" v="237"/>
          <ac:cxnSpMkLst>
            <pc:docMk/>
            <pc:sldMk cId="190867312" sldId="256"/>
            <ac:cxnSpMk id="31" creationId="{9376AFE1-826D-F62A-C00D-E59B670CEC7F}"/>
          </ac:cxnSpMkLst>
        </pc:cxnChg>
        <pc:cxnChg chg="del mod">
          <ac:chgData name="Marlene Ganslmeier" userId="45c49ef3-bcd5-408a-93eb-0ba43e091784" providerId="ADAL" clId="{4CFBB918-5BDE-40A6-A2B3-78B74F2ECAAA}" dt="2025-12-21T19:45:50.207" v="190" actId="478"/>
          <ac:cxnSpMkLst>
            <pc:docMk/>
            <pc:sldMk cId="190867312" sldId="256"/>
            <ac:cxnSpMk id="32" creationId="{7D18902B-FC18-FC10-A5B8-D584DE4ED00A}"/>
          </ac:cxnSpMkLst>
        </pc:cxnChg>
        <pc:cxnChg chg="del mod">
          <ac:chgData name="Marlene Ganslmeier" userId="45c49ef3-bcd5-408a-93eb-0ba43e091784" providerId="ADAL" clId="{4CFBB918-5BDE-40A6-A2B3-78B74F2ECAAA}" dt="2025-12-21T19:45:50.207" v="190" actId="478"/>
          <ac:cxnSpMkLst>
            <pc:docMk/>
            <pc:sldMk cId="190867312" sldId="256"/>
            <ac:cxnSpMk id="33" creationId="{E90407F4-636A-1D18-6A44-65B562780DEA}"/>
          </ac:cxnSpMkLst>
        </pc:cxnChg>
        <pc:cxnChg chg="mod">
          <ac:chgData name="Marlene Ganslmeier" userId="45c49ef3-bcd5-408a-93eb-0ba43e091784" providerId="ADAL" clId="{4CFBB918-5BDE-40A6-A2B3-78B74F2ECAAA}" dt="2025-12-21T19:46:53.386" v="237"/>
          <ac:cxnSpMkLst>
            <pc:docMk/>
            <pc:sldMk cId="190867312" sldId="256"/>
            <ac:cxnSpMk id="35" creationId="{1193B2C9-F06D-7DBF-EA92-9E0C9922DFA7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72C0F1-822F-2547-6B53-E41D6C0D20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36667D7-2E75-C229-CB48-1E2223E500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648CE5-D226-F822-D0F4-E8F513A5F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3055-8385-4A34-B506-D67E6FB62ACD}" type="datetimeFigureOut">
              <a:rPr lang="de-DE" smtClean="0"/>
              <a:t>04.02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61D71C-7D6E-0F72-3662-3C0F66246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A4509-60D2-2328-F354-51852388C0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68B33-56FB-4258-8886-9E8884B646D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2723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E9B56-931C-CB97-AC37-7AC0D0BE35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F9AC3B-E82B-42ED-EFAA-5D6BDCDF90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977170-17E2-B576-D64F-DB7D7F7AFB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3055-8385-4A34-B506-D67E6FB62ACD}" type="datetimeFigureOut">
              <a:rPr lang="de-DE" smtClean="0"/>
              <a:t>04.02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B7C758-6A67-9B6C-2D03-8CF3E4985E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9099AB-E2D0-135C-44B8-0F5F15F63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68B33-56FB-4258-8886-9E8884B646D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7758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E968977-55BB-D8E7-F3B4-DE106AFF46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5A6C9A-46A9-7CAD-B83D-8F4F603D38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813A34-EFA4-0A93-68FF-CF9819A09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3055-8385-4A34-B506-D67E6FB62ACD}" type="datetimeFigureOut">
              <a:rPr lang="de-DE" smtClean="0"/>
              <a:t>04.02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0A1917-E3E1-3F49-F93C-7631FA892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EFCDED-CEC8-73A4-FC69-586A9D8220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68B33-56FB-4258-8886-9E8884B646D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6436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7CE226-1B19-9E17-0ADB-5C092D5346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806E41-4FF4-6180-6BFB-533CB110B2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7E6B45-C42F-1A2F-069B-CF87C2E4F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3055-8385-4A34-B506-D67E6FB62ACD}" type="datetimeFigureOut">
              <a:rPr lang="de-DE" smtClean="0"/>
              <a:t>04.02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79ABC9-0EA4-F2A6-7906-E83555CFC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9F83A5-FF8D-187A-1FFF-317D7D466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68B33-56FB-4258-8886-9E8884B646D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7285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67D045-3528-7583-2FA5-4C289F959D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F1BCBC-C6B6-1992-E381-3F4F2414F4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FB519F-EF2A-4991-D303-7A0DB2C0F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3055-8385-4A34-B506-D67E6FB62ACD}" type="datetimeFigureOut">
              <a:rPr lang="de-DE" smtClean="0"/>
              <a:t>04.02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F6A622-16D5-3F08-0B9F-2E43339400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F4FEB7-11CF-0AE4-F803-451021DA4D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68B33-56FB-4258-8886-9E8884B646D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3131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11025-84D7-2076-8066-BDBE7A9835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4EC496-3BBC-D58D-6BC8-AC3A3D8917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ADE7D9-9B7C-1EE3-335D-22CF643B27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B4825E-4B6A-8CC9-9534-D3A5F19E7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3055-8385-4A34-B506-D67E6FB62ACD}" type="datetimeFigureOut">
              <a:rPr lang="de-DE" smtClean="0"/>
              <a:t>04.02.2026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D1DCA4-FEDA-C615-80FA-414294A80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2CD312-4E60-E372-3C18-B5CE44C47E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68B33-56FB-4258-8886-9E8884B646D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3181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F63156-E86E-FDF3-8604-6C369BD3A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540FA2-0884-660F-AF76-DC708995B4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E3D6DD-1605-C784-3DDB-B071FFAD7D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F48D3E-7E64-4FBA-0B2F-F1964919A16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6D71E0-AC06-E9C9-63EF-7F5151727C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F62ACEF-1363-C638-CA43-E2BFE9E89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3055-8385-4A34-B506-D67E6FB62ACD}" type="datetimeFigureOut">
              <a:rPr lang="de-DE" smtClean="0"/>
              <a:t>04.02.2026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F3B25FE-D4A4-971C-85B3-18538080D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9CE3A8-0CE2-D51F-FB57-64D8169CC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68B33-56FB-4258-8886-9E8884B646D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0194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EC7E5A-3A97-56B5-490F-F687A8E8C0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988F5D-DAAD-B988-4BB3-85C2BB0502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3055-8385-4A34-B506-D67E6FB62ACD}" type="datetimeFigureOut">
              <a:rPr lang="de-DE" smtClean="0"/>
              <a:t>04.02.2026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2C08795-6C30-5DCE-CF11-4552F124D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CD708D2-36E9-34B8-7CCA-CF9A7DBAD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68B33-56FB-4258-8886-9E8884B646D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0254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0285F0-FDCC-D56C-1ECC-561B95EE2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3055-8385-4A34-B506-D67E6FB62ACD}" type="datetimeFigureOut">
              <a:rPr lang="de-DE" smtClean="0"/>
              <a:t>04.02.2026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1856B2-3E8B-21E5-A367-8BA05FAA5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BC6C22-4223-F0F5-48B6-08B37AC51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68B33-56FB-4258-8886-9E8884B646D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5232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7D9641-9BC0-C403-638A-EFD967B53C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49028C-2484-8B18-221A-8993B901A1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F5956A-5358-14B5-4722-9DEABBB974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580B4A-6160-7A03-4C0B-96EE1231F5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3055-8385-4A34-B506-D67E6FB62ACD}" type="datetimeFigureOut">
              <a:rPr lang="de-DE" smtClean="0"/>
              <a:t>04.02.2026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B80469-0351-127F-2185-1D5FC3CCF1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BF95CC-D901-3BCB-8923-F0645641B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68B33-56FB-4258-8886-9E8884B646D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4221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B924B9-2BA4-A028-CDD0-D9FAA89548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2FC9278-C13C-476A-12E5-10837C2603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D47694-F3AB-93C3-4884-838FEC5562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04FE2D-5D28-A7F5-FB07-5F8F0A5D4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3055-8385-4A34-B506-D67E6FB62ACD}" type="datetimeFigureOut">
              <a:rPr lang="de-DE" smtClean="0"/>
              <a:t>04.02.2026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528B6D-CFF8-9FE5-9ECD-538DB4AAE1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6269E8-7BB5-BBE4-A411-CA05B112DA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68B33-56FB-4258-8886-9E8884B646D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3779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617A12-C558-4CDF-28D7-1B3ACCC2E3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643A66-6D55-7CD5-4F4C-982DC6AE5D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AD4D9B-8341-5CDA-07C8-B3DB40336F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E83055-8385-4A34-B506-D67E6FB62ACD}" type="datetimeFigureOut">
              <a:rPr lang="de-DE" smtClean="0"/>
              <a:t>04.02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7DC550-D93E-CDB1-120F-116616ABFC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F0E0AC-FA41-422D-C32C-6C7DE594C0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8F68B33-56FB-4258-8886-9E8884B646D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1265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4A7D2A8-F1EA-0C2D-65E1-F44665873BA0}"/>
              </a:ext>
            </a:extLst>
          </p:cNvPr>
          <p:cNvSpPr/>
          <p:nvPr/>
        </p:nvSpPr>
        <p:spPr>
          <a:xfrm>
            <a:off x="3719023" y="370996"/>
            <a:ext cx="3600000" cy="576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Participants included at Baseline N = 1159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3DE2DA3-5DE6-7FD3-FF91-6F2749F166E7}"/>
              </a:ext>
            </a:extLst>
          </p:cNvPr>
          <p:cNvSpPr/>
          <p:nvPr/>
        </p:nvSpPr>
        <p:spPr>
          <a:xfrm>
            <a:off x="3719023" y="1510955"/>
            <a:ext cx="3600000" cy="576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Participants with follow up </a:t>
            </a:r>
          </a:p>
          <a:p>
            <a:pPr algn="ctr"/>
            <a:r>
              <a:rPr lang="de-DE" dirty="0">
                <a:solidFill>
                  <a:schemeClr val="tx1"/>
                </a:solidFill>
              </a:rPr>
              <a:t>N = 568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0C251C0-E018-AB9D-F86F-7707C260ACFE}"/>
              </a:ext>
            </a:extLst>
          </p:cNvPr>
          <p:cNvSpPr/>
          <p:nvPr/>
        </p:nvSpPr>
        <p:spPr>
          <a:xfrm>
            <a:off x="3719023" y="2660571"/>
            <a:ext cx="3600000" cy="576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Proteomics Available</a:t>
            </a:r>
          </a:p>
          <a:p>
            <a:pPr algn="ctr"/>
            <a:r>
              <a:rPr lang="de-DE" dirty="0">
                <a:solidFill>
                  <a:schemeClr val="tx1"/>
                </a:solidFill>
              </a:rPr>
              <a:t>N= 521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AD4E727-6AC9-D3F5-E078-B4FCE8F3A531}"/>
              </a:ext>
            </a:extLst>
          </p:cNvPr>
          <p:cNvSpPr/>
          <p:nvPr/>
        </p:nvSpPr>
        <p:spPr>
          <a:xfrm>
            <a:off x="3719023" y="3799470"/>
            <a:ext cx="3600000" cy="576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Genetics Available</a:t>
            </a:r>
          </a:p>
          <a:p>
            <a:pPr algn="ctr"/>
            <a:r>
              <a:rPr lang="de-DE" dirty="0">
                <a:solidFill>
                  <a:schemeClr val="tx1"/>
                </a:solidFill>
              </a:rPr>
              <a:t>N =458</a:t>
            </a:r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E7957DA7-0A60-2CED-B8DE-B6EB84BB819E}"/>
              </a:ext>
            </a:extLst>
          </p:cNvPr>
          <p:cNvSpPr/>
          <p:nvPr/>
        </p:nvSpPr>
        <p:spPr>
          <a:xfrm>
            <a:off x="4579223" y="5637070"/>
            <a:ext cx="1879600" cy="711200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Prediabetes</a:t>
            </a:r>
          </a:p>
          <a:p>
            <a:pPr algn="ctr"/>
            <a:r>
              <a:rPr lang="de-DE" dirty="0">
                <a:solidFill>
                  <a:schemeClr val="tx1"/>
                </a:solidFill>
              </a:rPr>
              <a:t>N = 321</a:t>
            </a:r>
          </a:p>
        </p:txBody>
      </p:sp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CCB6C968-94D5-93AD-F026-67B87E8018A5}"/>
              </a:ext>
            </a:extLst>
          </p:cNvPr>
          <p:cNvSpPr/>
          <p:nvPr/>
        </p:nvSpPr>
        <p:spPr>
          <a:xfrm>
            <a:off x="6908096" y="5637070"/>
            <a:ext cx="1879600" cy="711200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T2D</a:t>
            </a:r>
          </a:p>
          <a:p>
            <a:pPr algn="ctr"/>
            <a:r>
              <a:rPr lang="de-DE" dirty="0">
                <a:solidFill>
                  <a:schemeClr val="tx1"/>
                </a:solidFill>
              </a:rPr>
              <a:t>N = 88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AE12058C-582F-AAF4-6AA3-FF7E367CA28B}"/>
              </a:ext>
            </a:extLst>
          </p:cNvPr>
          <p:cNvCxnSpPr>
            <a:cxnSpLocks/>
          </p:cNvCxnSpPr>
          <p:nvPr/>
        </p:nvCxnSpPr>
        <p:spPr>
          <a:xfrm>
            <a:off x="5528967" y="4372930"/>
            <a:ext cx="0" cy="829733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88454D9-27DA-5566-773D-CF2ECCD9B714}"/>
              </a:ext>
            </a:extLst>
          </p:cNvPr>
          <p:cNvCxnSpPr>
            <a:cxnSpLocks/>
          </p:cNvCxnSpPr>
          <p:nvPr/>
        </p:nvCxnSpPr>
        <p:spPr>
          <a:xfrm>
            <a:off x="3210038" y="5223552"/>
            <a:ext cx="4637858" cy="1494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B61BA512-D8ED-96EF-1106-9A4E55C67130}"/>
              </a:ext>
            </a:extLst>
          </p:cNvPr>
          <p:cNvSpPr/>
          <p:nvPr/>
        </p:nvSpPr>
        <p:spPr>
          <a:xfrm>
            <a:off x="2270238" y="5637070"/>
            <a:ext cx="1879600" cy="711200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NGR</a:t>
            </a:r>
          </a:p>
          <a:p>
            <a:pPr algn="ctr"/>
            <a:r>
              <a:rPr lang="de-DE" dirty="0">
                <a:solidFill>
                  <a:schemeClr val="tx1"/>
                </a:solidFill>
              </a:rPr>
              <a:t> N = 49 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46B22CD7-0DBF-F734-AB9C-EF5FAF751D5C}"/>
              </a:ext>
            </a:extLst>
          </p:cNvPr>
          <p:cNvCxnSpPr>
            <a:cxnSpLocks/>
          </p:cNvCxnSpPr>
          <p:nvPr/>
        </p:nvCxnSpPr>
        <p:spPr>
          <a:xfrm>
            <a:off x="3210038" y="5223552"/>
            <a:ext cx="0" cy="34925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D767F37E-384F-5B10-65CD-53C1A8C97653}"/>
              </a:ext>
            </a:extLst>
          </p:cNvPr>
          <p:cNvCxnSpPr>
            <a:cxnSpLocks/>
          </p:cNvCxnSpPr>
          <p:nvPr/>
        </p:nvCxnSpPr>
        <p:spPr>
          <a:xfrm>
            <a:off x="7847896" y="5223552"/>
            <a:ext cx="0" cy="34925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4" name="Group 13">
            <a:extLst>
              <a:ext uri="{FF2B5EF4-FFF2-40B4-BE49-F238E27FC236}">
                <a16:creationId xmlns:a16="http://schemas.microsoft.com/office/drawing/2014/main" id="{81FE4473-55E4-FF89-B36E-49F07844EE3C}"/>
              </a:ext>
            </a:extLst>
          </p:cNvPr>
          <p:cNvGrpSpPr/>
          <p:nvPr/>
        </p:nvGrpSpPr>
        <p:grpSpPr>
          <a:xfrm>
            <a:off x="5509079" y="868679"/>
            <a:ext cx="4549744" cy="711200"/>
            <a:chOff x="5517787" y="633548"/>
            <a:chExt cx="4549744" cy="711200"/>
          </a:xfrm>
        </p:grpSpPr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6978076B-BC2E-7A5C-BC63-2E81DD5D51FA}"/>
                </a:ext>
              </a:extLst>
            </p:cNvPr>
            <p:cNvCxnSpPr>
              <a:cxnSpLocks/>
            </p:cNvCxnSpPr>
            <p:nvPr/>
          </p:nvCxnSpPr>
          <p:spPr>
            <a:xfrm>
              <a:off x="5517787" y="989148"/>
              <a:ext cx="268042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Rectangle: Rounded Corners 28">
              <a:extLst>
                <a:ext uri="{FF2B5EF4-FFF2-40B4-BE49-F238E27FC236}">
                  <a16:creationId xmlns:a16="http://schemas.microsoft.com/office/drawing/2014/main" id="{99C1DEFB-B014-8205-7B12-F562F7C9C8F0}"/>
                </a:ext>
              </a:extLst>
            </p:cNvPr>
            <p:cNvSpPr/>
            <p:nvPr/>
          </p:nvSpPr>
          <p:spPr>
            <a:xfrm>
              <a:off x="8187931" y="633548"/>
              <a:ext cx="1879600" cy="711200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dirty="0">
                  <a:solidFill>
                    <a:schemeClr val="tx1"/>
                  </a:solidFill>
                </a:rPr>
                <a:t>No Follow Up</a:t>
              </a:r>
            </a:p>
          </p:txBody>
        </p: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DA629F87-20BD-60FD-34D0-579AC8A3ED64}"/>
                </a:ext>
              </a:extLst>
            </p:cNvPr>
            <p:cNvCxnSpPr>
              <a:cxnSpLocks/>
            </p:cNvCxnSpPr>
            <p:nvPr/>
          </p:nvCxnSpPr>
          <p:spPr>
            <a:xfrm>
              <a:off x="5527731" y="711865"/>
              <a:ext cx="0" cy="554567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B1B9C47C-9D57-E486-959A-6670FBCF3EAF}"/>
              </a:ext>
            </a:extLst>
          </p:cNvPr>
          <p:cNvGrpSpPr/>
          <p:nvPr/>
        </p:nvGrpSpPr>
        <p:grpSpPr>
          <a:xfrm>
            <a:off x="5519023" y="2040738"/>
            <a:ext cx="4549744" cy="711200"/>
            <a:chOff x="5517787" y="633548"/>
            <a:chExt cx="4549744" cy="711200"/>
          </a:xfrm>
        </p:grpSpPr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58DA4F21-F38A-9FDA-5D7C-DDE74124E68B}"/>
                </a:ext>
              </a:extLst>
            </p:cNvPr>
            <p:cNvCxnSpPr>
              <a:cxnSpLocks/>
            </p:cNvCxnSpPr>
            <p:nvPr/>
          </p:nvCxnSpPr>
          <p:spPr>
            <a:xfrm>
              <a:off x="5517787" y="989148"/>
              <a:ext cx="268042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Rectangle: Rounded Corners 16">
              <a:extLst>
                <a:ext uri="{FF2B5EF4-FFF2-40B4-BE49-F238E27FC236}">
                  <a16:creationId xmlns:a16="http://schemas.microsoft.com/office/drawing/2014/main" id="{4755DF2B-849E-FAAF-56B4-C866CF68EFBF}"/>
                </a:ext>
              </a:extLst>
            </p:cNvPr>
            <p:cNvSpPr/>
            <p:nvPr/>
          </p:nvSpPr>
          <p:spPr>
            <a:xfrm>
              <a:off x="8187931" y="633548"/>
              <a:ext cx="1879600" cy="711200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dirty="0">
                  <a:solidFill>
                    <a:schemeClr val="tx1"/>
                  </a:solidFill>
                </a:rPr>
                <a:t>No proteomics</a:t>
              </a: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D2348165-36E0-C5C2-B564-9D57DD6A2D4D}"/>
                </a:ext>
              </a:extLst>
            </p:cNvPr>
            <p:cNvCxnSpPr>
              <a:cxnSpLocks/>
            </p:cNvCxnSpPr>
            <p:nvPr/>
          </p:nvCxnSpPr>
          <p:spPr>
            <a:xfrm>
              <a:off x="5527731" y="711865"/>
              <a:ext cx="0" cy="554567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2CC8B946-F682-980F-778B-09DE6D2140CB}"/>
              </a:ext>
            </a:extLst>
          </p:cNvPr>
          <p:cNvGrpSpPr/>
          <p:nvPr/>
        </p:nvGrpSpPr>
        <p:grpSpPr>
          <a:xfrm>
            <a:off x="5519023" y="3173192"/>
            <a:ext cx="4549744" cy="711200"/>
            <a:chOff x="5517787" y="633548"/>
            <a:chExt cx="4549744" cy="711200"/>
          </a:xfrm>
        </p:grpSpPr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9376AFE1-826D-F62A-C00D-E59B670CEC7F}"/>
                </a:ext>
              </a:extLst>
            </p:cNvPr>
            <p:cNvCxnSpPr>
              <a:cxnSpLocks/>
            </p:cNvCxnSpPr>
            <p:nvPr/>
          </p:nvCxnSpPr>
          <p:spPr>
            <a:xfrm>
              <a:off x="5517787" y="989148"/>
              <a:ext cx="268042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Rectangle: Rounded Corners 33">
              <a:extLst>
                <a:ext uri="{FF2B5EF4-FFF2-40B4-BE49-F238E27FC236}">
                  <a16:creationId xmlns:a16="http://schemas.microsoft.com/office/drawing/2014/main" id="{0733E6EC-4F4F-A7D7-B8A7-B139641520B9}"/>
                </a:ext>
              </a:extLst>
            </p:cNvPr>
            <p:cNvSpPr/>
            <p:nvPr/>
          </p:nvSpPr>
          <p:spPr>
            <a:xfrm>
              <a:off x="8187931" y="633548"/>
              <a:ext cx="1879600" cy="711200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dirty="0">
                  <a:solidFill>
                    <a:schemeClr val="tx1"/>
                  </a:solidFill>
                </a:rPr>
                <a:t>No Genetics </a:t>
              </a:r>
            </a:p>
          </p:txBody>
        </p: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1193B2C9-F06D-7DBF-EA92-9E0C9922DFA7}"/>
                </a:ext>
              </a:extLst>
            </p:cNvPr>
            <p:cNvCxnSpPr>
              <a:cxnSpLocks/>
            </p:cNvCxnSpPr>
            <p:nvPr/>
          </p:nvCxnSpPr>
          <p:spPr>
            <a:xfrm>
              <a:off x="5527731" y="711865"/>
              <a:ext cx="0" cy="554567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38D50890-1873-3BE6-7E2F-F08E43ADD0D3}"/>
              </a:ext>
            </a:extLst>
          </p:cNvPr>
          <p:cNvCxnSpPr>
            <a:cxnSpLocks/>
          </p:cNvCxnSpPr>
          <p:nvPr/>
        </p:nvCxnSpPr>
        <p:spPr>
          <a:xfrm>
            <a:off x="5528967" y="5202663"/>
            <a:ext cx="0" cy="34925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0867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lene Ganslmeier</dc:creator>
  <cp:lastModifiedBy>Marlene Ganslmeier</cp:lastModifiedBy>
  <cp:revision>3</cp:revision>
  <dcterms:created xsi:type="dcterms:W3CDTF">2025-08-29T08:38:50Z</dcterms:created>
  <dcterms:modified xsi:type="dcterms:W3CDTF">2026-02-04T14:41:45Z</dcterms:modified>
</cp:coreProperties>
</file>